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  <p:sldId id="257" r:id="rId3"/>
  </p:sldIdLst>
  <p:sldSz cx="12192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6" d="100"/>
          <a:sy n="96" d="100"/>
        </p:scale>
        <p:origin x="115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cap="none" spc="0" normalizeH="0" baseline="0">
                <a:solidFill>
                  <a:sysClr val="windowText" lastClr="000000"/>
                </a:solidFill>
                <a:latin typeface="+mj-lt"/>
                <a:ea typeface="+mj-ea"/>
                <a:cs typeface="+mj-cs"/>
              </a:defRPr>
            </a:pPr>
            <a:r>
              <a:rPr lang="en-US" sz="1400" b="1" i="0" baseline="0">
                <a:effectLst/>
              </a:rPr>
              <a:t>Up-regulated genes in RTx2911 after inocculation</a:t>
            </a:r>
            <a:endParaRPr lang="en-US" sz="1400" b="1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cap="none" spc="0" normalizeH="0" baseline="0">
              <a:solidFill>
                <a:sysClr val="windowText" lastClr="000000"/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Biological function'!$E$7:$E$26</c:f>
              <c:strCache>
                <c:ptCount val="20"/>
                <c:pt idx="0">
                  <c:v>Response to stimulus </c:v>
                </c:pt>
                <c:pt idx="1">
                  <c:v>Lipid biosynthetic process </c:v>
                </c:pt>
                <c:pt idx="2">
                  <c:v>Protein phosphorylation </c:v>
                </c:pt>
                <c:pt idx="3">
                  <c:v>Biosynthetic process </c:v>
                </c:pt>
                <c:pt idx="4">
                  <c:v>Response to stress </c:v>
                </c:pt>
                <c:pt idx="5">
                  <c:v>Amino acid catabolic process </c:v>
                </c:pt>
                <c:pt idx="6">
                  <c:v>Cell wall macromolecule metabolism </c:v>
                </c:pt>
                <c:pt idx="7">
                  <c:v>L-phenylalanine metabolic process </c:v>
                </c:pt>
                <c:pt idx="8">
                  <c:v>Catabolic process </c:v>
                </c:pt>
                <c:pt idx="9">
                  <c:v>Carbohydrate metabolic process </c:v>
                </c:pt>
                <c:pt idx="10">
                  <c:v>Anion transport </c:v>
                </c:pt>
                <c:pt idx="11">
                  <c:v>Drug catabolic process </c:v>
                </c:pt>
                <c:pt idx="12">
                  <c:v>Oxylipin metabolic process </c:v>
                </c:pt>
                <c:pt idx="13">
                  <c:v>Lipid metabolic process </c:v>
                </c:pt>
                <c:pt idx="14">
                  <c:v>Organic anion transport </c:v>
                </c:pt>
                <c:pt idx="15">
                  <c:v>Oxidation-reduction process </c:v>
                </c:pt>
                <c:pt idx="16">
                  <c:v>Flavonoid biosynthetic process </c:v>
                </c:pt>
                <c:pt idx="17">
                  <c:v>Defense response to bacterium </c:v>
                </c:pt>
                <c:pt idx="18">
                  <c:v>Secondary metabolic process </c:v>
                </c:pt>
                <c:pt idx="19">
                  <c:v>Defense response </c:v>
                </c:pt>
              </c:strCache>
            </c:strRef>
          </c:cat>
          <c:val>
            <c:numRef>
              <c:f>'Biological function'!$F$7:$F$26</c:f>
              <c:numCache>
                <c:formatCode>General</c:formatCode>
                <c:ptCount val="20"/>
                <c:pt idx="0">
                  <c:v>114</c:v>
                </c:pt>
                <c:pt idx="1">
                  <c:v>23</c:v>
                </c:pt>
                <c:pt idx="2">
                  <c:v>63</c:v>
                </c:pt>
                <c:pt idx="3">
                  <c:v>170</c:v>
                </c:pt>
                <c:pt idx="4">
                  <c:v>65</c:v>
                </c:pt>
                <c:pt idx="5">
                  <c:v>15</c:v>
                </c:pt>
                <c:pt idx="6">
                  <c:v>10</c:v>
                </c:pt>
                <c:pt idx="7">
                  <c:v>4</c:v>
                </c:pt>
                <c:pt idx="8">
                  <c:v>65</c:v>
                </c:pt>
                <c:pt idx="9">
                  <c:v>47</c:v>
                </c:pt>
                <c:pt idx="10">
                  <c:v>16</c:v>
                </c:pt>
                <c:pt idx="11">
                  <c:v>20</c:v>
                </c:pt>
                <c:pt idx="12">
                  <c:v>4</c:v>
                </c:pt>
                <c:pt idx="13">
                  <c:v>43</c:v>
                </c:pt>
                <c:pt idx="14">
                  <c:v>13</c:v>
                </c:pt>
                <c:pt idx="15">
                  <c:v>87</c:v>
                </c:pt>
                <c:pt idx="16">
                  <c:v>6</c:v>
                </c:pt>
                <c:pt idx="17">
                  <c:v>12</c:v>
                </c:pt>
                <c:pt idx="18">
                  <c:v>22</c:v>
                </c:pt>
                <c:pt idx="19">
                  <c:v>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2A-42BC-B3F7-B68D248DF24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69"/>
        <c:axId val="395332552"/>
        <c:axId val="395333208"/>
      </c:barChart>
      <c:catAx>
        <c:axId val="395332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5333208"/>
        <c:crosses val="autoZero"/>
        <c:auto val="1"/>
        <c:lblAlgn val="ctr"/>
        <c:lblOffset val="100"/>
        <c:noMultiLvlLbl val="0"/>
      </c:catAx>
      <c:valAx>
        <c:axId val="3953332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cap="none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cap="none" baseline="0">
                    <a:solidFill>
                      <a:sysClr val="windowText" lastClr="000000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cap="none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5332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cap="none" spc="0" normalizeH="0" baseline="0">
                <a:solidFill>
                  <a:sysClr val="windowText" lastClr="000000"/>
                </a:solidFill>
                <a:latin typeface="+mj-lt"/>
                <a:ea typeface="+mj-ea"/>
                <a:cs typeface="+mj-cs"/>
              </a:defRPr>
            </a:pPr>
            <a:r>
              <a:rPr lang="en-US" sz="1400" b="1" i="0" baseline="0">
                <a:effectLst/>
              </a:rPr>
              <a:t>Down-regulated genes in RTx2911 after innoculation</a:t>
            </a:r>
            <a:endParaRPr lang="en-US" sz="1400" b="1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cap="none" spc="0" normalizeH="0" baseline="0">
              <a:solidFill>
                <a:sysClr val="windowText" lastClr="000000"/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'Biological function'!$K$7:$K$25</c:f>
              <c:strCache>
                <c:ptCount val="19"/>
                <c:pt idx="0">
                  <c:v>Glycerolipid metabolic process </c:v>
                </c:pt>
                <c:pt idx="1">
                  <c:v>Regulation of MAP kinase activity </c:v>
                </c:pt>
                <c:pt idx="2">
                  <c:v>Cellular metabolic compound salvage </c:v>
                </c:pt>
                <c:pt idx="3">
                  <c:v>Glucose metabolic process </c:v>
                </c:pt>
                <c:pt idx="4">
                  <c:v>Ether metabolic process </c:v>
                </c:pt>
                <c:pt idx="5">
                  <c:v>Actin filament bundle assembly </c:v>
                </c:pt>
                <c:pt idx="6">
                  <c:v>Ribosomal large subunit biogenesis </c:v>
                </c:pt>
                <c:pt idx="7">
                  <c:v>Amino acid biosynthetic process </c:v>
                </c:pt>
                <c:pt idx="8">
                  <c:v>Organonitrogen compound metabolism</c:v>
                </c:pt>
                <c:pt idx="9">
                  <c:v>Defense response to oomycetes </c:v>
                </c:pt>
                <c:pt idx="10">
                  <c:v>Photosynthetic electron transport chain </c:v>
                </c:pt>
                <c:pt idx="11">
                  <c:v>Protein repair </c:v>
                </c:pt>
                <c:pt idx="12">
                  <c:v>Energy quenching </c:v>
                </c:pt>
                <c:pt idx="13">
                  <c:v>Response to stimulus </c:v>
                </c:pt>
                <c:pt idx="14">
                  <c:v>Response to cytokinin </c:v>
                </c:pt>
                <c:pt idx="15">
                  <c:v>Cellular anion homeostasis </c:v>
                </c:pt>
                <c:pt idx="16">
                  <c:v>Oxidation-reduction process </c:v>
                </c:pt>
                <c:pt idx="17">
                  <c:v>Small molecule metabolic process </c:v>
                </c:pt>
                <c:pt idx="18">
                  <c:v>Photosynthesis </c:v>
                </c:pt>
              </c:strCache>
            </c:strRef>
          </c:cat>
          <c:val>
            <c:numRef>
              <c:f>'Biological function'!$L$7:$L$25</c:f>
              <c:numCache>
                <c:formatCode>General</c:formatCode>
                <c:ptCount val="19"/>
                <c:pt idx="0">
                  <c:v>10</c:v>
                </c:pt>
                <c:pt idx="1">
                  <c:v>2</c:v>
                </c:pt>
                <c:pt idx="2">
                  <c:v>5</c:v>
                </c:pt>
                <c:pt idx="3">
                  <c:v>5</c:v>
                </c:pt>
                <c:pt idx="4">
                  <c:v>4</c:v>
                </c:pt>
                <c:pt idx="5">
                  <c:v>3</c:v>
                </c:pt>
                <c:pt idx="6">
                  <c:v>7</c:v>
                </c:pt>
                <c:pt idx="7">
                  <c:v>11</c:v>
                </c:pt>
                <c:pt idx="8">
                  <c:v>160</c:v>
                </c:pt>
                <c:pt idx="9">
                  <c:v>3</c:v>
                </c:pt>
                <c:pt idx="10">
                  <c:v>6</c:v>
                </c:pt>
                <c:pt idx="11">
                  <c:v>4</c:v>
                </c:pt>
                <c:pt idx="12">
                  <c:v>3</c:v>
                </c:pt>
                <c:pt idx="13">
                  <c:v>106</c:v>
                </c:pt>
                <c:pt idx="14">
                  <c:v>9</c:v>
                </c:pt>
                <c:pt idx="15">
                  <c:v>3</c:v>
                </c:pt>
                <c:pt idx="16">
                  <c:v>79</c:v>
                </c:pt>
                <c:pt idx="17">
                  <c:v>60</c:v>
                </c:pt>
                <c:pt idx="18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40-458E-ACF8-7A6929C082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9"/>
        <c:axId val="475703896"/>
        <c:axId val="475704224"/>
      </c:barChart>
      <c:catAx>
        <c:axId val="475703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cap="none" spc="0" normalizeH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5704224"/>
        <c:crosses val="autoZero"/>
        <c:auto val="1"/>
        <c:lblAlgn val="ctr"/>
        <c:lblOffset val="100"/>
        <c:noMultiLvlLbl val="0"/>
      </c:catAx>
      <c:valAx>
        <c:axId val="4757042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cap="none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cap="none" baseline="0">
                    <a:solidFill>
                      <a:sysClr val="windowText" lastClr="000000"/>
                    </a:solidFill>
                  </a:rPr>
                  <a:t>Number of gen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cap="none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57038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2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46836"/>
            <a:ext cx="10363200" cy="286512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322446"/>
            <a:ext cx="9144000" cy="198691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651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347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38150"/>
            <a:ext cx="2628900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38150"/>
            <a:ext cx="7734300" cy="697420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156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01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051688"/>
            <a:ext cx="10515600" cy="342328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507358"/>
            <a:ext cx="10515600" cy="180022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875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90750"/>
            <a:ext cx="5181600" cy="52216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90750"/>
            <a:ext cx="5181600" cy="52216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795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38152"/>
            <a:ext cx="1051560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017396"/>
            <a:ext cx="5157787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006090"/>
            <a:ext cx="5157787" cy="44215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017396"/>
            <a:ext cx="5183188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006090"/>
            <a:ext cx="5183188" cy="442150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139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582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75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84912"/>
            <a:ext cx="6172200" cy="58483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233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48640"/>
            <a:ext cx="3932237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84912"/>
            <a:ext cx="6172200" cy="58483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468880"/>
            <a:ext cx="3932237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787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38152"/>
            <a:ext cx="1051560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90750"/>
            <a:ext cx="1051560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B778D-3749-4C51-85B9-05EF4B4F30B3}" type="datetimeFigureOut">
              <a:rPr lang="en-US" smtClean="0"/>
              <a:t>2/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627622"/>
            <a:ext cx="41148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627622"/>
            <a:ext cx="27432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4A580-A225-4016-9B1F-FE946FEA52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042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3E2455-AB72-4B24-B1F2-9F516DFB2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7930" y="2190750"/>
            <a:ext cx="11618844" cy="21990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>
              <a:lnSpc>
                <a:spcPct val="150000"/>
              </a:lnSpc>
              <a:buNone/>
            </a:pPr>
            <a:r>
              <a:rPr lang="en-US" sz="2000" b="1" dirty="0">
                <a:solidFill>
                  <a:srgbClr val="21212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criptome analysis of early stages of sorghum grain mold disease reveals defense regulators and metabolic pathways associated with resistance</a:t>
            </a:r>
          </a:p>
          <a:p>
            <a:pPr marL="0" indent="0" algn="ctr">
              <a:lnSpc>
                <a:spcPct val="150000"/>
              </a:lnSpc>
              <a:buNone/>
            </a:pPr>
            <a:endParaRPr lang="en-US" sz="2000" dirty="0"/>
          </a:p>
          <a:p>
            <a:pPr marL="0" indent="0" algn="ctr">
              <a:lnSpc>
                <a:spcPct val="150000"/>
              </a:lnSpc>
              <a:buNone/>
            </a:pPr>
            <a:r>
              <a:rPr lang="en-US" sz="2000" dirty="0"/>
              <a:t>Habte Nida, Sanghun Lee, Ying Li, Tesfaye Mengiste</a:t>
            </a:r>
          </a:p>
        </p:txBody>
      </p:sp>
    </p:spTree>
    <p:extLst>
      <p:ext uri="{BB962C8B-B14F-4D97-AF65-F5344CB8AC3E}">
        <p14:creationId xmlns:p14="http://schemas.microsoft.com/office/powerpoint/2010/main" val="134552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233275"/>
              </p:ext>
            </p:extLst>
          </p:nvPr>
        </p:nvGraphicFramePr>
        <p:xfrm>
          <a:off x="331404" y="1681370"/>
          <a:ext cx="5500688" cy="4848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724506"/>
              </p:ext>
            </p:extLst>
          </p:nvPr>
        </p:nvGraphicFramePr>
        <p:xfrm>
          <a:off x="6010995" y="1691879"/>
          <a:ext cx="6048374" cy="48458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6557048" y="1388199"/>
            <a:ext cx="3275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5486" y="1377687"/>
            <a:ext cx="3275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31404" y="219192"/>
            <a:ext cx="14205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3697848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09</TotalTime>
  <Words>53</Words>
  <Application>Microsoft Office PowerPoint</Application>
  <PresentationFormat>Custom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Purdue University - AgI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bte Nida Chikssa</dc:creator>
  <cp:lastModifiedBy>Mengiste, Tesfaye</cp:lastModifiedBy>
  <cp:revision>25</cp:revision>
  <dcterms:created xsi:type="dcterms:W3CDTF">2020-10-05T21:04:59Z</dcterms:created>
  <dcterms:modified xsi:type="dcterms:W3CDTF">2021-02-09T14:45:36Z</dcterms:modified>
</cp:coreProperties>
</file>